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custDataLst>
    <p:tags r:id="rId7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3" autoAdjust="0"/>
    <p:restoredTop sz="94660"/>
  </p:normalViewPr>
  <p:slideViewPr>
    <p:cSldViewPr snapToGrid="0">
      <p:cViewPr varScale="1">
        <p:scale>
          <a:sx n="129" d="100"/>
          <a:sy n="129" d="100"/>
        </p:scale>
        <p:origin x="401" y="6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1468A-C86D-4409-B252-EB23ACE633D6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576A1-1833-43A6-9A97-7762C5F6727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1468A-C86D-4409-B252-EB23ACE633D6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576A1-1833-43A6-9A97-7762C5F6727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1468A-C86D-4409-B252-EB23ACE633D6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576A1-1833-43A6-9A97-7762C5F6727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1468A-C86D-4409-B252-EB23ACE633D6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576A1-1833-43A6-9A97-7762C5F6727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1468A-C86D-4409-B252-EB23ACE633D6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576A1-1833-43A6-9A97-7762C5F6727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1468A-C86D-4409-B252-EB23ACE633D6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576A1-1833-43A6-9A97-7762C5F6727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1468A-C86D-4409-B252-EB23ACE633D6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576A1-1833-43A6-9A97-7762C5F6727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1468A-C86D-4409-B252-EB23ACE633D6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576A1-1833-43A6-9A97-7762C5F6727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1468A-C86D-4409-B252-EB23ACE633D6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576A1-1833-43A6-9A97-7762C5F6727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1468A-C86D-4409-B252-EB23ACE633D6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576A1-1833-43A6-9A97-7762C5F6727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1468A-C86D-4409-B252-EB23ACE633D6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576A1-1833-43A6-9A97-7762C5F6727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71468A-C86D-4409-B252-EB23ACE633D6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4576A1-1833-43A6-9A97-7762C5F6727D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86875" y="5454632"/>
            <a:ext cx="8543416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charset="0"/>
                <a:cs typeface="Times New Roman" panose="02020603050405020304" charset="0"/>
              </a:rPr>
              <a:t>Fig. </a:t>
            </a:r>
            <a:r>
              <a:rPr lang="en-US" dirty="0" err="1">
                <a:latin typeface="Times New Roman" panose="02020603050405020304" charset="0"/>
                <a:cs typeface="Times New Roman" panose="02020603050405020304" charset="0"/>
              </a:rPr>
              <a:t>S1</a:t>
            </a:r>
            <a:r>
              <a:rPr lang="en-US" dirty="0">
                <a:latin typeface="Times New Roman" panose="02020603050405020304" charset="0"/>
                <a:cs typeface="Times New Roman" panose="02020603050405020304" charset="0"/>
              </a:rPr>
              <a:t>. Genome wide plotting of Euclidean distance (ED) values identifies a significant association of the </a:t>
            </a:r>
            <a:r>
              <a:rPr lang="en-US" i="1" dirty="0">
                <a:latin typeface="Times New Roman" panose="02020603050405020304" charset="0"/>
                <a:cs typeface="Times New Roman" panose="02020603050405020304" charset="0"/>
              </a:rPr>
              <a:t>naked seed </a:t>
            </a:r>
            <a:r>
              <a:rPr lang="en-US" dirty="0">
                <a:latin typeface="Times New Roman" panose="02020603050405020304" charset="0"/>
                <a:cs typeface="Times New Roman" panose="02020603050405020304" charset="0"/>
              </a:rPr>
              <a:t>(</a:t>
            </a:r>
            <a:r>
              <a:rPr lang="en-US" i="1" dirty="0">
                <a:latin typeface="Times New Roman" panose="02020603050405020304" charset="0"/>
                <a:cs typeface="Times New Roman" panose="02020603050405020304" charset="0"/>
              </a:rPr>
              <a:t>n</a:t>
            </a:r>
            <a:r>
              <a:rPr lang="en-US" dirty="0">
                <a:latin typeface="Times New Roman" panose="02020603050405020304" charset="0"/>
                <a:cs typeface="Times New Roman" panose="02020603050405020304" charset="0"/>
              </a:rPr>
              <a:t>) locus in a 4.24 Mbp physical interval of </a:t>
            </a:r>
            <a:r>
              <a:rPr lang="en-US" i="1" dirty="0">
                <a:latin typeface="Times New Roman" panose="02020603050405020304" charset="0"/>
                <a:cs typeface="Times New Roman" panose="02020603050405020304" charset="0"/>
              </a:rPr>
              <a:t>C. moschata </a:t>
            </a:r>
            <a:r>
              <a:rPr lang="en-US" dirty="0">
                <a:latin typeface="Times New Roman" panose="02020603050405020304" charset="0"/>
                <a:cs typeface="Times New Roman" panose="02020603050405020304" charset="0"/>
              </a:rPr>
              <a:t>Chromosome 17 in BSA-Seq. </a:t>
            </a:r>
            <a:endParaRPr lang="en-US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988315" y="1670770"/>
            <a:ext cx="7032920" cy="351646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6ef7828d-20d1-475b-94ce-f1eebced3555"/>
  <p:tag name="COMMONDATA" val="eyJoZGlkIjoiMDY3M2I1OTEzMmI5YTFiODQ2NGZmZjZlMDg3MDI0ODgifQ==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2</Words>
  <Application>WPS 演示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Calibri</vt:lpstr>
      <vt:lpstr>微软雅黑</vt:lpstr>
      <vt:lpstr>Arial Unicode MS</vt:lpstr>
      <vt:lpstr>Calibri Light</vt:lpstr>
      <vt:lpstr>等线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qun Weng</dc:creator>
  <cp:lastModifiedBy>hp</cp:lastModifiedBy>
  <cp:revision>4</cp:revision>
  <dcterms:created xsi:type="dcterms:W3CDTF">2023-03-06T22:04:00Z</dcterms:created>
  <dcterms:modified xsi:type="dcterms:W3CDTF">2023-03-13T14:35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A52F664E3C4C4DEC8B95680A96FA1E52</vt:lpwstr>
  </property>
  <property fmtid="{D5CDD505-2E9C-101B-9397-08002B2CF9AE}" pid="3" name="KSOProductBuildVer">
    <vt:lpwstr>2052-11.1.0.13703</vt:lpwstr>
  </property>
</Properties>
</file>